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DE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542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1C3EA1-1200-41C9-A3E8-C75BEF4B413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73BE01-E3E2-4FD2-BDD2-12D951F864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643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73BE01-E3E2-4FD2-BDD2-12D951F8640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7575424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4379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3306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75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6335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1498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5542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907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1986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9023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3810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3076684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71A33-B801-43F2-9667-D23B467B8BE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DE265-48E5-4645-9B87-B201CF4F74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62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20"/>
          <p:cNvSpPr/>
          <p:nvPr/>
        </p:nvSpPr>
        <p:spPr>
          <a:xfrm>
            <a:off x="7215335" y="2749356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GB" sz="1000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en-GB" sz="10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7700568" y="2749356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6535655" y="2749356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GB" sz="1000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7019131" y="2749356"/>
            <a:ext cx="197946" cy="19969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4901284" y="1955780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35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/>
          <p:cNvSpPr/>
          <p:nvPr/>
        </p:nvSpPr>
        <p:spPr>
          <a:xfrm>
            <a:off x="6525136" y="1955780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GB" sz="1000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91"/>
          <p:cNvSpPr/>
          <p:nvPr/>
        </p:nvSpPr>
        <p:spPr>
          <a:xfrm>
            <a:off x="7012115" y="1955780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T2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/>
          <p:cNvCxnSpPr/>
          <p:nvPr/>
        </p:nvCxnSpPr>
        <p:spPr>
          <a:xfrm>
            <a:off x="7779370" y="2050688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29031" y="1284134"/>
            <a:ext cx="1681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PLANT VECTORS</a:t>
            </a:r>
            <a:endParaRPr lang="en-GB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804052" y="1561133"/>
            <a:ext cx="814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804052" y="2340658"/>
            <a:ext cx="814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usion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243731" y="1923528"/>
            <a:ext cx="6901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Z+W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243731" y="2745853"/>
            <a:ext cx="6901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Z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s-W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243731" y="3301669"/>
            <a:ext cx="6901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Z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m-W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243731" y="3876210"/>
            <a:ext cx="6901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Z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g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W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39263" y="4695555"/>
            <a:ext cx="1080655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GB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s of the different plant </a:t>
            </a:r>
            <a:r>
              <a:rPr lang="en-GB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</a:t>
            </a:r>
            <a:r>
              <a:rPr lang="en-GB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&amp; </a:t>
            </a:r>
            <a:r>
              <a:rPr lang="en-GB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t</a:t>
            </a:r>
            <a:r>
              <a:rPr lang="en-GB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ectors. The backbone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to create the constructs was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inary vector pZK3B (Kuroda et al., 2010). LB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eft border;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os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moter of </a:t>
            </a:r>
            <a:r>
              <a:rPr lang="en-GB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paline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from 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efaciens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pt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ene conferring the kanamycin resistance; </a:t>
            </a:r>
            <a:r>
              <a:rPr lang="en-GB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os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erminator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palin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gene from 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efaciens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35S, 35S promoter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the cauliflower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saic virus;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GB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ˈ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TR,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anslated region of 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cotiana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acum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cohol dehydrogenase;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p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ransit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e of the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sum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tivum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isCO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mall subunit;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 codon optimised carotene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droxylase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GB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evundimonas</a:t>
            </a:r>
            <a:r>
              <a:rPr lang="en-GB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 SD212;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 codon optimised carotene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tolas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evundimonas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212;  T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GB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erminator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abidospsis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aliana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 shock protein 18.2 gene; DT2, succession of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sp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os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rminators; RB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 border; s, small linker; m, medium linker; </a:t>
            </a:r>
            <a:r>
              <a:rPr lang="en-GB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g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long linker.</a:t>
            </a:r>
          </a:p>
        </p:txBody>
      </p:sp>
      <p:sp>
        <p:nvSpPr>
          <p:cNvPr id="67" name="Rectangle 66"/>
          <p:cNvSpPr/>
          <p:nvPr/>
        </p:nvSpPr>
        <p:spPr>
          <a:xfrm>
            <a:off x="5659784" y="1955780"/>
            <a:ext cx="576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6237449" y="1955780"/>
            <a:ext cx="288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9699222" y="1950840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r>
              <a:rPr lang="en-GB" sz="1000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endParaRPr lang="en-GB" sz="10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/>
          <p:cNvSpPr/>
          <p:nvPr/>
        </p:nvSpPr>
        <p:spPr>
          <a:xfrm>
            <a:off x="10186201" y="1950840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8830367" y="1950840"/>
            <a:ext cx="576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9408032" y="1950840"/>
            <a:ext cx="288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8071867" y="1950840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35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2610877" y="1955780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3369384" y="1955780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pt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3856363" y="1955780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/>
          <p:cNvCxnSpPr/>
          <p:nvPr/>
        </p:nvCxnSpPr>
        <p:spPr>
          <a:xfrm>
            <a:off x="4615803" y="2050688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Rectangle 101"/>
          <p:cNvSpPr/>
          <p:nvPr/>
        </p:nvSpPr>
        <p:spPr>
          <a:xfrm>
            <a:off x="4904787" y="2749356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35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102"/>
          <p:cNvSpPr/>
          <p:nvPr/>
        </p:nvSpPr>
        <p:spPr>
          <a:xfrm>
            <a:off x="5663287" y="2749356"/>
            <a:ext cx="576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103"/>
          <p:cNvSpPr/>
          <p:nvPr/>
        </p:nvSpPr>
        <p:spPr>
          <a:xfrm>
            <a:off x="6240952" y="2749356"/>
            <a:ext cx="288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104"/>
          <p:cNvSpPr/>
          <p:nvPr/>
        </p:nvSpPr>
        <p:spPr>
          <a:xfrm>
            <a:off x="2614380" y="2749356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05"/>
          <p:cNvSpPr/>
          <p:nvPr/>
        </p:nvSpPr>
        <p:spPr>
          <a:xfrm>
            <a:off x="3372887" y="2749356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pt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Rectangle 126"/>
          <p:cNvSpPr/>
          <p:nvPr/>
        </p:nvSpPr>
        <p:spPr>
          <a:xfrm>
            <a:off x="3859866" y="2749356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Straight Connector 127"/>
          <p:cNvCxnSpPr/>
          <p:nvPr/>
        </p:nvCxnSpPr>
        <p:spPr>
          <a:xfrm>
            <a:off x="4619306" y="2847453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Rectangle 128"/>
          <p:cNvSpPr/>
          <p:nvPr/>
        </p:nvSpPr>
        <p:spPr>
          <a:xfrm>
            <a:off x="7206587" y="3340853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GB" sz="1000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en-GB" sz="10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129"/>
          <p:cNvSpPr/>
          <p:nvPr/>
        </p:nvSpPr>
        <p:spPr>
          <a:xfrm>
            <a:off x="7691820" y="3340853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Rectangle 130"/>
          <p:cNvSpPr/>
          <p:nvPr/>
        </p:nvSpPr>
        <p:spPr>
          <a:xfrm>
            <a:off x="6526907" y="3340853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GB" sz="1000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Rectangle 131"/>
          <p:cNvSpPr/>
          <p:nvPr/>
        </p:nvSpPr>
        <p:spPr>
          <a:xfrm>
            <a:off x="7010383" y="3340853"/>
            <a:ext cx="197946" cy="19969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32"/>
          <p:cNvSpPr/>
          <p:nvPr/>
        </p:nvSpPr>
        <p:spPr>
          <a:xfrm>
            <a:off x="4896039" y="3340853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35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Rectangle 133"/>
          <p:cNvSpPr/>
          <p:nvPr/>
        </p:nvSpPr>
        <p:spPr>
          <a:xfrm>
            <a:off x="5654539" y="3340853"/>
            <a:ext cx="576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Rectangle 134"/>
          <p:cNvSpPr/>
          <p:nvPr/>
        </p:nvSpPr>
        <p:spPr>
          <a:xfrm>
            <a:off x="6232204" y="3340853"/>
            <a:ext cx="288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Rectangle 135"/>
          <p:cNvSpPr/>
          <p:nvPr/>
        </p:nvSpPr>
        <p:spPr>
          <a:xfrm>
            <a:off x="2605632" y="3340853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36"/>
          <p:cNvSpPr/>
          <p:nvPr/>
        </p:nvSpPr>
        <p:spPr>
          <a:xfrm>
            <a:off x="3364139" y="3340853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pt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Rectangle 137"/>
          <p:cNvSpPr/>
          <p:nvPr/>
        </p:nvSpPr>
        <p:spPr>
          <a:xfrm>
            <a:off x="3851118" y="3340853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Straight Connector 138"/>
          <p:cNvCxnSpPr/>
          <p:nvPr/>
        </p:nvCxnSpPr>
        <p:spPr>
          <a:xfrm>
            <a:off x="4610558" y="3453545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Rectangle 139"/>
          <p:cNvSpPr/>
          <p:nvPr/>
        </p:nvSpPr>
        <p:spPr>
          <a:xfrm>
            <a:off x="7210090" y="3934732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GB" sz="1000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en-GB" sz="10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Rectangle 140"/>
          <p:cNvSpPr/>
          <p:nvPr/>
        </p:nvSpPr>
        <p:spPr>
          <a:xfrm>
            <a:off x="7695323" y="3934732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Rectangle 148"/>
          <p:cNvSpPr/>
          <p:nvPr/>
        </p:nvSpPr>
        <p:spPr>
          <a:xfrm>
            <a:off x="6530410" y="3934732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</a:t>
            </a:r>
            <a:r>
              <a:rPr lang="en-GB" sz="1000" dirty="0" err="1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endParaRPr lang="en-GB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Rectangle 153"/>
          <p:cNvSpPr/>
          <p:nvPr/>
        </p:nvSpPr>
        <p:spPr>
          <a:xfrm>
            <a:off x="7013886" y="3934732"/>
            <a:ext cx="197946" cy="19969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g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Rectangle 154"/>
          <p:cNvSpPr/>
          <p:nvPr/>
        </p:nvSpPr>
        <p:spPr>
          <a:xfrm>
            <a:off x="4899542" y="3934732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35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Rectangle 155"/>
          <p:cNvSpPr/>
          <p:nvPr/>
        </p:nvSpPr>
        <p:spPr>
          <a:xfrm>
            <a:off x="5658042" y="3934732"/>
            <a:ext cx="576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Rectangle 156"/>
          <p:cNvSpPr/>
          <p:nvPr/>
        </p:nvSpPr>
        <p:spPr>
          <a:xfrm>
            <a:off x="6235707" y="3934732"/>
            <a:ext cx="288000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Rectangle 157"/>
          <p:cNvSpPr/>
          <p:nvPr/>
        </p:nvSpPr>
        <p:spPr>
          <a:xfrm>
            <a:off x="2609135" y="3934732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Rectangle 158"/>
          <p:cNvSpPr/>
          <p:nvPr/>
        </p:nvSpPr>
        <p:spPr>
          <a:xfrm>
            <a:off x="3367642" y="3934732"/>
            <a:ext cx="483476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pt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Rectangle 159"/>
          <p:cNvSpPr/>
          <p:nvPr/>
        </p:nvSpPr>
        <p:spPr>
          <a:xfrm>
            <a:off x="3854621" y="3934732"/>
            <a:ext cx="763752" cy="19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Nos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Straight Connector 160"/>
          <p:cNvCxnSpPr/>
          <p:nvPr/>
        </p:nvCxnSpPr>
        <p:spPr>
          <a:xfrm>
            <a:off x="4614061" y="4047424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/>
          <p:nvPr/>
        </p:nvCxnSpPr>
        <p:spPr>
          <a:xfrm>
            <a:off x="2326380" y="2050688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>
            <a:off x="2317632" y="2847453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/>
          <p:cNvCxnSpPr/>
          <p:nvPr/>
        </p:nvCxnSpPr>
        <p:spPr>
          <a:xfrm>
            <a:off x="2317632" y="3453545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/>
          <p:cNvCxnSpPr/>
          <p:nvPr/>
        </p:nvCxnSpPr>
        <p:spPr>
          <a:xfrm>
            <a:off x="2317632" y="4047424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/>
          <p:cNvCxnSpPr/>
          <p:nvPr/>
        </p:nvCxnSpPr>
        <p:spPr>
          <a:xfrm>
            <a:off x="10956987" y="2050688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/>
          <p:cNvCxnSpPr/>
          <p:nvPr/>
        </p:nvCxnSpPr>
        <p:spPr>
          <a:xfrm>
            <a:off x="8464320" y="2847453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/>
          <p:cNvCxnSpPr/>
          <p:nvPr/>
        </p:nvCxnSpPr>
        <p:spPr>
          <a:xfrm>
            <a:off x="8464320" y="3453545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/>
          <p:cNvCxnSpPr/>
          <p:nvPr/>
        </p:nvCxnSpPr>
        <p:spPr>
          <a:xfrm>
            <a:off x="8464320" y="4047424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Rectangle 172"/>
          <p:cNvSpPr/>
          <p:nvPr/>
        </p:nvSpPr>
        <p:spPr>
          <a:xfrm>
            <a:off x="11252021" y="1948799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Rectangle 173"/>
          <p:cNvSpPr/>
          <p:nvPr/>
        </p:nvSpPr>
        <p:spPr>
          <a:xfrm>
            <a:off x="8758367" y="2749356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Rectangle 174"/>
          <p:cNvSpPr/>
          <p:nvPr/>
        </p:nvSpPr>
        <p:spPr>
          <a:xfrm>
            <a:off x="8758367" y="3345570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Rectangle 175"/>
          <p:cNvSpPr/>
          <p:nvPr/>
        </p:nvSpPr>
        <p:spPr>
          <a:xfrm>
            <a:off x="8758367" y="3941784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tangle 176"/>
          <p:cNvSpPr/>
          <p:nvPr/>
        </p:nvSpPr>
        <p:spPr>
          <a:xfrm>
            <a:off x="1957632" y="2749356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Rectangle 177"/>
          <p:cNvSpPr/>
          <p:nvPr/>
        </p:nvSpPr>
        <p:spPr>
          <a:xfrm>
            <a:off x="1957632" y="3345570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Rectangle 178"/>
          <p:cNvSpPr/>
          <p:nvPr/>
        </p:nvSpPr>
        <p:spPr>
          <a:xfrm>
            <a:off x="1957632" y="3941784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Rectangle 179"/>
          <p:cNvSpPr/>
          <p:nvPr/>
        </p:nvSpPr>
        <p:spPr>
          <a:xfrm>
            <a:off x="1983831" y="1963441"/>
            <a:ext cx="360000" cy="1996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GB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9481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</TotalTime>
  <Words>251</Words>
  <Application>Microsoft Office PowerPoint</Application>
  <PresentationFormat>Widescreen</PresentationFormat>
  <Paragraphs>6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